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0799763" cy="899953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8D32A3-09DD-4149-81ED-C0320003CC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39280" y="360000"/>
            <a:ext cx="9721800" cy="15001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ctr">
            <a:noAutofit/>
          </a:bodyPr>
          <a:p>
            <a:pPr indent="0" algn="ctr">
              <a:buNone/>
              <a:tabLst>
                <a:tab algn="l" pos="0"/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5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39280" y="2099880"/>
            <a:ext cx="9721800" cy="28332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39280" y="5202720"/>
            <a:ext cx="9721800" cy="28332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9E43C2-C37D-4764-ACD3-B3493A4C12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39280" y="360000"/>
            <a:ext cx="9721800" cy="15001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ctr">
            <a:noAutofit/>
          </a:bodyPr>
          <a:p>
            <a:pPr indent="0" algn="ctr">
              <a:buNone/>
              <a:tabLst>
                <a:tab algn="l" pos="0"/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5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39280" y="2099880"/>
            <a:ext cx="4744080" cy="28332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520960" y="2099880"/>
            <a:ext cx="4744080" cy="28332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39280" y="5202720"/>
            <a:ext cx="4744080" cy="28332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520960" y="5202720"/>
            <a:ext cx="4744080" cy="28332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D8E832-37E0-4B9C-8229-2C8461E9CA6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39280" y="360000"/>
            <a:ext cx="9721800" cy="15001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ctr">
            <a:noAutofit/>
          </a:bodyPr>
          <a:p>
            <a:pPr indent="0" algn="ctr">
              <a:buNone/>
              <a:tabLst>
                <a:tab algn="l" pos="0"/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5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39280" y="2099880"/>
            <a:ext cx="3130200" cy="28332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826440" y="2099880"/>
            <a:ext cx="3130200" cy="28332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113600" y="2099880"/>
            <a:ext cx="3130200" cy="28332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39280" y="5202720"/>
            <a:ext cx="3130200" cy="28332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826440" y="5202720"/>
            <a:ext cx="3130200" cy="28332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113600" y="5202720"/>
            <a:ext cx="3130200" cy="28332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EE554D-D082-4DAE-AFE6-17C49F6D1E5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39280" y="360000"/>
            <a:ext cx="9721800" cy="15001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ctr">
            <a:noAutofit/>
          </a:bodyPr>
          <a:p>
            <a:pPr indent="0" algn="ctr">
              <a:buNone/>
              <a:tabLst>
                <a:tab algn="l" pos="0"/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5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39280" y="2099880"/>
            <a:ext cx="9721800" cy="594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049"/>
              </a:spcBef>
              <a:buNone/>
              <a:tabLst>
                <a:tab algn="l" pos="0"/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E7AB13-F0E3-4304-99A1-5C1F1F822B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39280" y="360000"/>
            <a:ext cx="9721800" cy="15001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ctr">
            <a:noAutofit/>
          </a:bodyPr>
          <a:p>
            <a:pPr indent="0" algn="ctr">
              <a:buNone/>
              <a:tabLst>
                <a:tab algn="l" pos="0"/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5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39280" y="2099880"/>
            <a:ext cx="9721800" cy="594036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1BD024-DD62-4120-9FB0-00AB837E6E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39280" y="360000"/>
            <a:ext cx="9721800" cy="15001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ctr">
            <a:noAutofit/>
          </a:bodyPr>
          <a:p>
            <a:pPr indent="0" algn="ctr">
              <a:buNone/>
              <a:tabLst>
                <a:tab algn="l" pos="0"/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5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39280" y="2099880"/>
            <a:ext cx="4744080" cy="594036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520960" y="2099880"/>
            <a:ext cx="4744080" cy="594036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D42C83-480E-43EC-9318-26F1F0AB19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39280" y="360000"/>
            <a:ext cx="9721800" cy="15001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ctr">
            <a:noAutofit/>
          </a:bodyPr>
          <a:p>
            <a:pPr indent="0" algn="ctr">
              <a:buNone/>
              <a:tabLst>
                <a:tab algn="l" pos="0"/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5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ED8F8C-8E32-4D18-9A8C-F986DB72E0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39280" y="360000"/>
            <a:ext cx="9721800" cy="6954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049"/>
              </a:spcBef>
              <a:tabLst>
                <a:tab algn="l" pos="0"/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EF35C3-4782-4326-B0ED-1D861880E6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39280" y="360000"/>
            <a:ext cx="9721800" cy="15001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ctr">
            <a:noAutofit/>
          </a:bodyPr>
          <a:p>
            <a:pPr indent="0" algn="ctr">
              <a:buNone/>
              <a:tabLst>
                <a:tab algn="l" pos="0"/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5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39280" y="2099880"/>
            <a:ext cx="4744080" cy="28332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520960" y="2099880"/>
            <a:ext cx="4744080" cy="594036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39280" y="5202720"/>
            <a:ext cx="4744080" cy="28332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9C0BC7-0DF8-40D2-8538-F7243A05BE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39280" y="360000"/>
            <a:ext cx="9721800" cy="15001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ctr">
            <a:noAutofit/>
          </a:bodyPr>
          <a:p>
            <a:pPr indent="0" algn="ctr">
              <a:buNone/>
              <a:tabLst>
                <a:tab algn="l" pos="0"/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5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39280" y="2099880"/>
            <a:ext cx="4744080" cy="594036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520960" y="2099880"/>
            <a:ext cx="4744080" cy="28332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520960" y="5202720"/>
            <a:ext cx="4744080" cy="28332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86C7E4-1896-45D2-A2CD-23F4783F53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39280" y="360000"/>
            <a:ext cx="9721800" cy="15001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ctr">
            <a:noAutofit/>
          </a:bodyPr>
          <a:p>
            <a:pPr indent="0" algn="ctr">
              <a:buNone/>
              <a:tabLst>
                <a:tab algn="l" pos="0"/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5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39280" y="2099880"/>
            <a:ext cx="4744080" cy="28332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520960" y="2099880"/>
            <a:ext cx="4744080" cy="28332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39280" y="5202720"/>
            <a:ext cx="9721800" cy="283320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58DD38-51A0-46E1-A154-A7F797E18B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39280" y="360000"/>
            <a:ext cx="9721800" cy="150012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ctr">
            <a:noAutofit/>
          </a:bodyPr>
          <a:p>
            <a:pPr indent="0" algn="ctr">
              <a:buNone/>
              <a:tabLst>
                <a:tab algn="l" pos="0"/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r>
              <a:rPr b="0" lang="en-US" sz="57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5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39280" y="2099880"/>
            <a:ext cx="9721800" cy="594036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rmAutofit/>
          </a:bodyPr>
          <a:p>
            <a:pPr marL="447840" indent="-447840">
              <a:spcBef>
                <a:spcPts val="1049"/>
              </a:spcBef>
              <a:buClr>
                <a:srgbClr val="000000"/>
              </a:buClr>
              <a:buFont typeface="Arial"/>
              <a:buChar char="•"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  <a:p>
            <a:pPr lvl="1" marL="969840" indent="-372960">
              <a:spcBef>
                <a:spcPts val="1049"/>
              </a:spcBef>
              <a:buClr>
                <a:srgbClr val="000000"/>
              </a:buClr>
              <a:buFont typeface="Arial"/>
              <a:buChar char="–"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  <a:p>
            <a:pPr lvl="2" marL="1492200" indent="-298440">
              <a:spcBef>
                <a:spcPts val="1049"/>
              </a:spcBef>
              <a:buClr>
                <a:srgbClr val="000000"/>
              </a:buClr>
              <a:buFont typeface="Arial"/>
              <a:buChar char="•"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  <a:p>
            <a:pPr lvl="3" marL="2087640" indent="-298440">
              <a:spcBef>
                <a:spcPts val="1049"/>
              </a:spcBef>
              <a:buClr>
                <a:srgbClr val="000000"/>
              </a:buClr>
              <a:buFont typeface="Arial"/>
              <a:buChar char="–"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  <a:p>
            <a:pPr lvl="4" marL="2684520" indent="-298440">
              <a:spcBef>
                <a:spcPts val="1049"/>
              </a:spcBef>
              <a:buClr>
                <a:srgbClr val="000000"/>
              </a:buClr>
              <a:buFont typeface="Arial"/>
              <a:buChar char="»"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  <a:p>
            <a:pPr lvl="5" marL="2684520" indent="-298440">
              <a:spcBef>
                <a:spcPts val="1049"/>
              </a:spcBef>
              <a:buClr>
                <a:srgbClr val="000000"/>
              </a:buClr>
              <a:buFont typeface="Arial"/>
              <a:buChar char="»"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  <a:p>
            <a:pPr lvl="6" marL="2684520" indent="-298440">
              <a:spcBef>
                <a:spcPts val="1049"/>
              </a:spcBef>
              <a:buClr>
                <a:srgbClr val="000000"/>
              </a:buClr>
              <a:buFont typeface="Arial"/>
              <a:buChar char="»"/>
              <a:tabLst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39280" y="8197560"/>
            <a:ext cx="2521080" cy="62388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Autofit/>
          </a:bodyPr>
          <a:lstStyle>
            <a:lvl1pPr indent="0">
              <a:buNone/>
              <a:tabLst>
                <a:tab algn="l" pos="0"/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691080" y="8197560"/>
            <a:ext cx="3419280" cy="62388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Autofit/>
          </a:bodyPr>
          <a:lstStyle>
            <a:lvl1pPr indent="0" algn="ctr">
              <a:buNone/>
              <a:tabLst>
                <a:tab algn="l" pos="0"/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740720" y="8197560"/>
            <a:ext cx="2520720" cy="623880"/>
          </a:xfrm>
          <a:prstGeom prst="rect">
            <a:avLst/>
          </a:prstGeom>
          <a:noFill/>
          <a:ln w="0">
            <a:noFill/>
          </a:ln>
        </p:spPr>
        <p:txBody>
          <a:bodyPr lIns="119160" rIns="119160" tIns="59760" bIns="59760" anchor="t">
            <a:noAutofit/>
          </a:bodyPr>
          <a:lstStyle>
            <a:lvl1pPr indent="0" algn="r">
              <a:buNone/>
              <a:tabLst>
                <a:tab algn="l" pos="0"/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193760"/>
                <a:tab algn="l" pos="2387520"/>
                <a:tab algn="l" pos="3581280"/>
                <a:tab algn="l" pos="4775040"/>
                <a:tab algn="l" pos="5969160"/>
                <a:tab algn="l" pos="7162920"/>
                <a:tab algn="l" pos="8356680"/>
                <a:tab algn="l" pos="9550440"/>
                <a:tab algn="l" pos="10744200"/>
              </a:tabLst>
            </a:pPr>
            <a:fld id="{C4A1187A-D206-453F-8BD8-C914017A6619}" type="slidenum">
              <a:rPr b="0" lang="en-US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448000" y="4146480"/>
            <a:ext cx="5256000" cy="253224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519280" y="2717640"/>
            <a:ext cx="1584360" cy="75888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319640" y="2717640"/>
            <a:ext cx="1584360" cy="75888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6119640" y="990720"/>
            <a:ext cx="1584360" cy="2593800"/>
          </a:xfrm>
          <a:custGeom>
            <a:avLst/>
            <a:gdLst>
              <a:gd name="textAreaLeft" fmla="*/ 77040 w 1584360"/>
              <a:gd name="textAreaRight" fmla="*/ 1507320 w 1584360"/>
              <a:gd name="textAreaTop" fmla="*/ 77040 h 2593800"/>
              <a:gd name="textAreaBottom" fmla="*/ 2516760 h 2593800"/>
            </a:gdLst>
            <a:ahLst/>
            <a:rect l="textAreaLeft" t="textAreaTop" r="textAreaRight" b="textAreaBottom"/>
            <a:pathLst>
              <a:path w="21600" h="35359">
                <a:moveTo>
                  <a:pt x="3600" y="0"/>
                </a:moveTo>
                <a:arcTo wR="3600" hR="3600" stAng="16200000" swAng="-5400000"/>
                <a:lnTo>
                  <a:pt x="0" y="31759"/>
                </a:lnTo>
                <a:arcTo wR="3600" hR="3600" stAng="10800000" swAng="-5400000"/>
                <a:lnTo>
                  <a:pt x="18000" y="35359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6192720" y="1998720"/>
            <a:ext cx="1440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isordered Protei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311640" y="3581280"/>
            <a:ext cx="0" cy="505080"/>
          </a:xfrm>
          <a:prstGeom prst="line">
            <a:avLst/>
          </a:prstGeom>
          <a:ln w="38160">
            <a:solidFill>
              <a:srgbClr val="000000"/>
            </a:solidFill>
            <a:miter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5184720" y="3584520"/>
            <a:ext cx="0" cy="501840"/>
          </a:xfrm>
          <a:prstGeom prst="line">
            <a:avLst/>
          </a:prstGeom>
          <a:ln w="38160">
            <a:solidFill>
              <a:srgbClr val="000000"/>
            </a:solidFill>
            <a:miter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6912000" y="3581280"/>
            <a:ext cx="0" cy="505080"/>
          </a:xfrm>
          <a:prstGeom prst="line">
            <a:avLst/>
          </a:prstGeom>
          <a:ln w="38160">
            <a:solidFill>
              <a:srgbClr val="000000"/>
            </a:solidFill>
            <a:miter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448000" y="7180200"/>
            <a:ext cx="1728720" cy="86688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625840" y="7373880"/>
            <a:ext cx="1368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rue Positive Rate (TPR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248000" y="7180200"/>
            <a:ext cx="1729080" cy="86688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425840" y="7373880"/>
            <a:ext cx="1368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alse Positive Rate (FPR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6048360" y="7180200"/>
            <a:ext cx="1728720" cy="86688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5977080" y="7256520"/>
            <a:ext cx="18716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raction of Disordered Proteins predicted to be binding site (F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519280" y="2160720"/>
            <a:ext cx="3384720" cy="0"/>
          </a:xfrm>
          <a:prstGeom prst="line">
            <a:avLst/>
          </a:prstGeom>
          <a:ln w="255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519280" y="1528920"/>
            <a:ext cx="1584360" cy="3981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505240" y="1494000"/>
            <a:ext cx="1584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hort Disordered Binding Sites (1/3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319640" y="1528920"/>
            <a:ext cx="1584360" cy="3981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392720" y="1494000"/>
            <a:ext cx="1439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lobular Proteins (1/3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0" name=""/>
          <p:cNvGrpSpPr/>
          <p:nvPr/>
        </p:nvGrpSpPr>
        <p:grpSpPr>
          <a:xfrm>
            <a:off x="2448000" y="990720"/>
            <a:ext cx="3529080" cy="1079280"/>
            <a:chOff x="2448000" y="990720"/>
            <a:chExt cx="3529080" cy="1079280"/>
          </a:xfrm>
        </p:grpSpPr>
        <p:sp>
          <p:nvSpPr>
            <p:cNvPr id="61" name=""/>
            <p:cNvSpPr/>
            <p:nvPr/>
          </p:nvSpPr>
          <p:spPr>
            <a:xfrm>
              <a:off x="2448000" y="990720"/>
              <a:ext cx="3529080" cy="107928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168720" y="990720"/>
              <a:ext cx="2087640" cy="368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800" spc="-1" strike="noStrike">
                  <a:solidFill>
                    <a:srgbClr val="000000"/>
                  </a:solidFill>
                  <a:latin typeface="Arial"/>
                </a:rPr>
                <a:t>Testing subset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3" name=""/>
          <p:cNvSpPr/>
          <p:nvPr/>
        </p:nvSpPr>
        <p:spPr>
          <a:xfrm>
            <a:off x="2476440" y="2835360"/>
            <a:ext cx="1656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hort Disordered Binding Sites (2/3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4383000" y="2862360"/>
            <a:ext cx="1440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lobular Proteins (2/3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5" name=""/>
          <p:cNvGrpSpPr/>
          <p:nvPr/>
        </p:nvGrpSpPr>
        <p:grpSpPr>
          <a:xfrm>
            <a:off x="2448000" y="2286000"/>
            <a:ext cx="3529080" cy="1295280"/>
            <a:chOff x="2448000" y="2286000"/>
            <a:chExt cx="3529080" cy="1295280"/>
          </a:xfrm>
        </p:grpSpPr>
        <p:sp>
          <p:nvSpPr>
            <p:cNvPr id="66" name=""/>
            <p:cNvSpPr/>
            <p:nvPr/>
          </p:nvSpPr>
          <p:spPr>
            <a:xfrm>
              <a:off x="2448000" y="2286000"/>
              <a:ext cx="3529080" cy="129528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168720" y="2286000"/>
              <a:ext cx="2087640" cy="368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800" spc="-1" strike="noStrike">
                  <a:solidFill>
                    <a:srgbClr val="000000"/>
                  </a:solidFill>
                  <a:latin typeface="Arial"/>
                </a:rPr>
                <a:t>Training subset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8" name=""/>
          <p:cNvSpPr/>
          <p:nvPr/>
        </p:nvSpPr>
        <p:spPr>
          <a:xfrm>
            <a:off x="8280360" y="4143240"/>
            <a:ext cx="1944720" cy="2589480"/>
          </a:xfrm>
          <a:custGeom>
            <a:avLst/>
            <a:gdLst>
              <a:gd name="textAreaLeft" fmla="*/ 94680 w 1944720"/>
              <a:gd name="textAreaRight" fmla="*/ 1850040 w 1944720"/>
              <a:gd name="textAreaTop" fmla="*/ 94680 h 2589480"/>
              <a:gd name="textAreaBottom" fmla="*/ 2494800 h 2589480"/>
            </a:gdLst>
            <a:ahLst/>
            <a:rect l="textAreaLeft" t="textAreaTop" r="textAreaRight" b="textAreaBottom"/>
            <a:pathLst>
              <a:path w="21600" h="28760">
                <a:moveTo>
                  <a:pt x="3600" y="0"/>
                </a:moveTo>
                <a:arcTo wR="3600" hR="3600" stAng="16200000" swAng="-5400000"/>
                <a:lnTo>
                  <a:pt x="0" y="25160"/>
                </a:lnTo>
                <a:arcTo wR="3600" hR="3600" stAng="10800000" swAng="-5400000"/>
                <a:lnTo>
                  <a:pt x="18000" y="28760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7721640" y="5238720"/>
            <a:ext cx="506520" cy="360360"/>
          </a:xfrm>
          <a:prstGeom prst="leftArrow">
            <a:avLst>
              <a:gd name="adj1" fmla="val 49778"/>
              <a:gd name="adj2" fmla="val 35361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8174160" y="4464000"/>
            <a:ext cx="2131920" cy="232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andom parameter se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1 - (w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, w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, p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, p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, p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2 - (w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, w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, p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, p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, p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3 - (w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, w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, p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, p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, p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…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144,000 - (w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, w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, p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, p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, p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571680" y="4935600"/>
            <a:ext cx="1152360" cy="104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nergy predictor matri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i="1" lang="en-US" sz="1600" spc="-1" strike="noStrike" baseline="-25000">
                <a:solidFill>
                  <a:srgbClr val="000000"/>
                </a:solidFill>
                <a:latin typeface="Arial"/>
              </a:rPr>
              <a:t>ij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076560" y="4230720"/>
            <a:ext cx="403236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NCHO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097080" y="4835520"/>
            <a:ext cx="3961080" cy="151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S, E</a:t>
            </a:r>
            <a:r>
              <a:rPr b="1" i="1" lang="en-US" sz="1800" spc="-1" strike="noStrike" baseline="-25000">
                <a:solidFill>
                  <a:srgbClr val="000000"/>
                </a:solidFill>
                <a:latin typeface="Arial"/>
              </a:rPr>
              <a:t>int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, E</a:t>
            </a:r>
            <a:r>
              <a:rPr b="1" i="1" lang="en-US" sz="1800" spc="-1" strike="noStrike" baseline="-25000">
                <a:solidFill>
                  <a:srgbClr val="000000"/>
                </a:solidFill>
                <a:latin typeface="Arial"/>
              </a:rPr>
              <a:t>ga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calculated for every protein in all datase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Prediction based on their linear combin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311640" y="6678720"/>
            <a:ext cx="0" cy="501480"/>
          </a:xfrm>
          <a:prstGeom prst="line">
            <a:avLst/>
          </a:prstGeom>
          <a:ln w="38160">
            <a:solidFill>
              <a:srgbClr val="000000"/>
            </a:solidFill>
            <a:miter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5184720" y="6678720"/>
            <a:ext cx="0" cy="501480"/>
          </a:xfrm>
          <a:prstGeom prst="line">
            <a:avLst/>
          </a:prstGeom>
          <a:ln w="38160">
            <a:solidFill>
              <a:srgbClr val="000000"/>
            </a:solidFill>
            <a:miter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6912000" y="6678720"/>
            <a:ext cx="0" cy="501480"/>
          </a:xfrm>
          <a:prstGeom prst="line">
            <a:avLst/>
          </a:prstGeom>
          <a:ln w="38160">
            <a:solidFill>
              <a:srgbClr val="000000"/>
            </a:solidFill>
            <a:miter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7920000" y="990720"/>
            <a:ext cx="792360" cy="2593800"/>
          </a:xfrm>
          <a:custGeom>
            <a:avLst/>
            <a:gdLst>
              <a:gd name="textAreaLeft" fmla="*/ 0 w 792360"/>
              <a:gd name="textAreaRight" fmla="*/ 286200 w 792360"/>
              <a:gd name="textAreaTop" fmla="*/ 67320 h 2593800"/>
              <a:gd name="textAreaBottom" fmla="*/ 2526480 h 25938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63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8856720" y="2089080"/>
            <a:ext cx="143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ataset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8136000" y="7180200"/>
            <a:ext cx="576360" cy="866880"/>
          </a:xfrm>
          <a:custGeom>
            <a:avLst/>
            <a:gdLst>
              <a:gd name="textAreaLeft" fmla="*/ 0 w 576360"/>
              <a:gd name="textAreaRight" fmla="*/ 208080 w 576360"/>
              <a:gd name="textAreaTop" fmla="*/ 22320 h 866880"/>
              <a:gd name="textAreaBottom" fmla="*/ 844560 h 8668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63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8712360" y="7253280"/>
            <a:ext cx="17287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Evaluation of the parameter se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428760" y="3492360"/>
            <a:ext cx="1439640" cy="7923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571680" y="3492360"/>
            <a:ext cx="11523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1336680"/>
                <a:tab algn="l" pos="2673360"/>
                <a:tab algn="l" pos="4010040"/>
                <a:tab algn="l" pos="5346720"/>
                <a:tab algn="l" pos="6683400"/>
                <a:tab algn="l" pos="8020080"/>
                <a:tab algn="l" pos="9356760"/>
                <a:tab algn="l" pos="106934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onomeric globular protein datase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428760" y="4861080"/>
            <a:ext cx="1439640" cy="108108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031760" y="4338720"/>
            <a:ext cx="287280" cy="503280"/>
          </a:xfrm>
          <a:prstGeom prst="downArrow">
            <a:avLst>
              <a:gd name="adj1" fmla="val 50000"/>
              <a:gd name="adj2" fmla="val 43797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rot="10800000">
            <a:off x="1917360" y="5221080"/>
            <a:ext cx="506520" cy="360360"/>
          </a:xfrm>
          <a:prstGeom prst="leftArrow">
            <a:avLst>
              <a:gd name="adj1" fmla="val 49778"/>
              <a:gd name="adj2" fmla="val 35361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22280" y="2844720"/>
            <a:ext cx="144000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1336680"/>
                <a:tab algn="l" pos="2673360"/>
                <a:tab algn="l" pos="4010040"/>
                <a:tab algn="l" pos="5346720"/>
                <a:tab algn="l" pos="6683400"/>
                <a:tab algn="l" pos="8020080"/>
                <a:tab algn="l" pos="9356760"/>
                <a:tab algn="l" pos="1069344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UPr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141640" y="2484360"/>
            <a:ext cx="0" cy="2664000"/>
          </a:xfrm>
          <a:prstGeom prst="line">
            <a:avLst/>
          </a:prstGeom>
          <a:ln w="255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2141640" y="5653080"/>
            <a:ext cx="0" cy="1008000"/>
          </a:xfrm>
          <a:prstGeom prst="line">
            <a:avLst/>
          </a:prstGeom>
          <a:ln w="255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4968720" y="5508720"/>
            <a:ext cx="360360" cy="504720"/>
          </a:xfrm>
          <a:prstGeom prst="downArrow">
            <a:avLst>
              <a:gd name="adj1" fmla="val 50000"/>
              <a:gd name="adj2" fmla="val 35015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1336680"/>
                <a:tab algn="l" pos="2673360"/>
                <a:tab algn="l" pos="4010040"/>
                <a:tab algn="l" pos="5346720"/>
                <a:tab algn="l" pos="6683400"/>
                <a:tab algn="l" pos="8020080"/>
                <a:tab algn="l" pos="9356760"/>
                <a:tab algn="l" pos="106934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flipV="1">
            <a:off x="2521080" y="5363640"/>
            <a:ext cx="792000" cy="73080"/>
          </a:xfrm>
          <a:prstGeom prst="line">
            <a:avLst/>
          </a:prstGeom>
          <a:ln w="316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flipH="1" flipV="1">
            <a:off x="6768720" y="5363640"/>
            <a:ext cx="792360" cy="73080"/>
          </a:xfrm>
          <a:prstGeom prst="line">
            <a:avLst/>
          </a:prstGeom>
          <a:ln w="31680">
            <a:solidFill>
              <a:srgbClr val="000000"/>
            </a:solidFill>
            <a:miter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flipH="1">
            <a:off x="6768720" y="5580000"/>
            <a:ext cx="792360" cy="576360"/>
          </a:xfrm>
          <a:prstGeom prst="line">
            <a:avLst/>
          </a:prstGeom>
          <a:ln w="31680">
            <a:solidFill>
              <a:srgbClr val="000000"/>
            </a:solidFill>
            <a:miter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27T14:56:34Z</dcterms:created>
  <dc:creator>balint</dc:creator>
  <dc:description/>
  <dc:language>en-US</dc:language>
  <cp:lastModifiedBy>Bálint Mészáros</cp:lastModifiedBy>
  <dcterms:modified xsi:type="dcterms:W3CDTF">2009-03-02T17:46:09Z</dcterms:modified>
  <cp:revision>4</cp:revision>
  <dc:subject/>
  <dc:title>1. dia</dc:title>
</cp:coreProperties>
</file>